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07" r:id="rId2"/>
    <p:sldId id="308" r:id="rId3"/>
  </p:sldIdLst>
  <p:sldSz cx="12700000" cy="13970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2" userDrawn="1">
          <p15:clr>
            <a:srgbClr val="A4A3A4"/>
          </p15:clr>
        </p15:guide>
        <p15:guide id="2" pos="24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7A4"/>
    <a:srgbClr val="FD61D1"/>
    <a:srgbClr val="E76BF3"/>
    <a:srgbClr val="B983FF"/>
    <a:srgbClr val="619CFF"/>
    <a:srgbClr val="00B0F6"/>
    <a:srgbClr val="00BCD8"/>
    <a:srgbClr val="00C0AF"/>
    <a:srgbClr val="00BF7D"/>
    <a:srgbClr val="00BA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9201E95-914C-426C-8AD8-8E99867AC7F6}" v="19" dt="2025-03-26T07:50:59.3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625" autoAdjust="0"/>
    <p:restoredTop sz="94694"/>
  </p:normalViewPr>
  <p:slideViewPr>
    <p:cSldViewPr snapToGrid="0" showGuides="1">
      <p:cViewPr varScale="1">
        <p:scale>
          <a:sx n="43" d="100"/>
          <a:sy n="43" d="100"/>
        </p:scale>
        <p:origin x="2505" y="255"/>
      </p:cViewPr>
      <p:guideLst>
        <p:guide orient="horz" pos="272"/>
        <p:guide pos="24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ECA596-41A4-1249-A45E-83559C542135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25650" y="1143000"/>
            <a:ext cx="2806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5B3753-2265-CD4A-BFB2-F06A67F6C5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18816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52500" y="2286296"/>
            <a:ext cx="10795000" cy="4863630"/>
          </a:xfrm>
        </p:spPr>
        <p:txBody>
          <a:bodyPr anchor="b"/>
          <a:lstStyle>
            <a:lvl1pPr algn="ctr">
              <a:defRPr sz="833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87500" y="7337485"/>
            <a:ext cx="9525000" cy="3372849"/>
          </a:xfrm>
        </p:spPr>
        <p:txBody>
          <a:bodyPr/>
          <a:lstStyle>
            <a:lvl1pPr marL="0" indent="0" algn="ctr">
              <a:buNone/>
              <a:defRPr sz="3333"/>
            </a:lvl1pPr>
            <a:lvl2pPr marL="635011" indent="0" algn="ctr">
              <a:buNone/>
              <a:defRPr sz="2778"/>
            </a:lvl2pPr>
            <a:lvl3pPr marL="1270021" indent="0" algn="ctr">
              <a:buNone/>
              <a:defRPr sz="2500"/>
            </a:lvl3pPr>
            <a:lvl4pPr marL="1905032" indent="0" algn="ctr">
              <a:buNone/>
              <a:defRPr sz="2222"/>
            </a:lvl4pPr>
            <a:lvl5pPr marL="2540043" indent="0" algn="ctr">
              <a:buNone/>
              <a:defRPr sz="2222"/>
            </a:lvl5pPr>
            <a:lvl6pPr marL="3175053" indent="0" algn="ctr">
              <a:buNone/>
              <a:defRPr sz="2222"/>
            </a:lvl6pPr>
            <a:lvl7pPr marL="3810064" indent="0" algn="ctr">
              <a:buNone/>
              <a:defRPr sz="2222"/>
            </a:lvl7pPr>
            <a:lvl8pPr marL="4445076" indent="0" algn="ctr">
              <a:buNone/>
              <a:defRPr sz="2222"/>
            </a:lvl8pPr>
            <a:lvl9pPr marL="5080086" indent="0" algn="ctr">
              <a:buNone/>
              <a:defRPr sz="2222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268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4538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88438" y="743773"/>
            <a:ext cx="2738438" cy="1183892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73126" y="743773"/>
            <a:ext cx="8056563" cy="1183892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201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872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6511" y="3482803"/>
            <a:ext cx="10953750" cy="5811131"/>
          </a:xfrm>
        </p:spPr>
        <p:txBody>
          <a:bodyPr anchor="b"/>
          <a:lstStyle>
            <a:lvl1pPr>
              <a:defRPr sz="833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511" y="9348909"/>
            <a:ext cx="10953750" cy="3055936"/>
          </a:xfrm>
        </p:spPr>
        <p:txBody>
          <a:bodyPr/>
          <a:lstStyle>
            <a:lvl1pPr marL="0" indent="0">
              <a:buNone/>
              <a:defRPr sz="3333">
                <a:solidFill>
                  <a:schemeClr val="tx1"/>
                </a:solidFill>
              </a:defRPr>
            </a:lvl1pPr>
            <a:lvl2pPr marL="635011" indent="0">
              <a:buNone/>
              <a:defRPr sz="2778">
                <a:solidFill>
                  <a:schemeClr val="tx1">
                    <a:tint val="75000"/>
                  </a:schemeClr>
                </a:solidFill>
              </a:defRPr>
            </a:lvl2pPr>
            <a:lvl3pPr marL="1270021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3pPr>
            <a:lvl4pPr marL="1905032" indent="0">
              <a:buNone/>
              <a:defRPr sz="2222">
                <a:solidFill>
                  <a:schemeClr val="tx1">
                    <a:tint val="75000"/>
                  </a:schemeClr>
                </a:solidFill>
              </a:defRPr>
            </a:lvl4pPr>
            <a:lvl5pPr marL="2540043" indent="0">
              <a:buNone/>
              <a:defRPr sz="2222">
                <a:solidFill>
                  <a:schemeClr val="tx1">
                    <a:tint val="75000"/>
                  </a:schemeClr>
                </a:solidFill>
              </a:defRPr>
            </a:lvl5pPr>
            <a:lvl6pPr marL="3175053" indent="0">
              <a:buNone/>
              <a:defRPr sz="2222">
                <a:solidFill>
                  <a:schemeClr val="tx1">
                    <a:tint val="75000"/>
                  </a:schemeClr>
                </a:solidFill>
              </a:defRPr>
            </a:lvl6pPr>
            <a:lvl7pPr marL="3810064" indent="0">
              <a:buNone/>
              <a:defRPr sz="2222">
                <a:solidFill>
                  <a:schemeClr val="tx1">
                    <a:tint val="75000"/>
                  </a:schemeClr>
                </a:solidFill>
              </a:defRPr>
            </a:lvl7pPr>
            <a:lvl8pPr marL="4445076" indent="0">
              <a:buNone/>
              <a:defRPr sz="2222">
                <a:solidFill>
                  <a:schemeClr val="tx1">
                    <a:tint val="75000"/>
                  </a:schemeClr>
                </a:solidFill>
              </a:defRPr>
            </a:lvl8pPr>
            <a:lvl9pPr marL="5080086" indent="0">
              <a:buNone/>
              <a:defRPr sz="22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27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73125" y="3718867"/>
            <a:ext cx="5397500" cy="88638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29375" y="3718867"/>
            <a:ext cx="5397500" cy="88638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3789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4779" y="743777"/>
            <a:ext cx="10953750" cy="270022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4781" y="3424592"/>
            <a:ext cx="5372694" cy="1678339"/>
          </a:xfrm>
        </p:spPr>
        <p:txBody>
          <a:bodyPr anchor="b"/>
          <a:lstStyle>
            <a:lvl1pPr marL="0" indent="0">
              <a:buNone/>
              <a:defRPr sz="3333" b="1"/>
            </a:lvl1pPr>
            <a:lvl2pPr marL="635011" indent="0">
              <a:buNone/>
              <a:defRPr sz="2778" b="1"/>
            </a:lvl2pPr>
            <a:lvl3pPr marL="1270021" indent="0">
              <a:buNone/>
              <a:defRPr sz="2500" b="1"/>
            </a:lvl3pPr>
            <a:lvl4pPr marL="1905032" indent="0">
              <a:buNone/>
              <a:defRPr sz="2222" b="1"/>
            </a:lvl4pPr>
            <a:lvl5pPr marL="2540043" indent="0">
              <a:buNone/>
              <a:defRPr sz="2222" b="1"/>
            </a:lvl5pPr>
            <a:lvl6pPr marL="3175053" indent="0">
              <a:buNone/>
              <a:defRPr sz="2222" b="1"/>
            </a:lvl6pPr>
            <a:lvl7pPr marL="3810064" indent="0">
              <a:buNone/>
              <a:defRPr sz="2222" b="1"/>
            </a:lvl7pPr>
            <a:lvl8pPr marL="4445076" indent="0">
              <a:buNone/>
              <a:defRPr sz="2222" b="1"/>
            </a:lvl8pPr>
            <a:lvl9pPr marL="5080086" indent="0">
              <a:buNone/>
              <a:defRPr sz="222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74781" y="5102931"/>
            <a:ext cx="5372694" cy="750564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29376" y="3424592"/>
            <a:ext cx="5399154" cy="1678339"/>
          </a:xfrm>
        </p:spPr>
        <p:txBody>
          <a:bodyPr anchor="b"/>
          <a:lstStyle>
            <a:lvl1pPr marL="0" indent="0">
              <a:buNone/>
              <a:defRPr sz="3333" b="1"/>
            </a:lvl1pPr>
            <a:lvl2pPr marL="635011" indent="0">
              <a:buNone/>
              <a:defRPr sz="2778" b="1"/>
            </a:lvl2pPr>
            <a:lvl3pPr marL="1270021" indent="0">
              <a:buNone/>
              <a:defRPr sz="2500" b="1"/>
            </a:lvl3pPr>
            <a:lvl4pPr marL="1905032" indent="0">
              <a:buNone/>
              <a:defRPr sz="2222" b="1"/>
            </a:lvl4pPr>
            <a:lvl5pPr marL="2540043" indent="0">
              <a:buNone/>
              <a:defRPr sz="2222" b="1"/>
            </a:lvl5pPr>
            <a:lvl6pPr marL="3175053" indent="0">
              <a:buNone/>
              <a:defRPr sz="2222" b="1"/>
            </a:lvl6pPr>
            <a:lvl7pPr marL="3810064" indent="0">
              <a:buNone/>
              <a:defRPr sz="2222" b="1"/>
            </a:lvl7pPr>
            <a:lvl8pPr marL="4445076" indent="0">
              <a:buNone/>
              <a:defRPr sz="2222" b="1"/>
            </a:lvl8pPr>
            <a:lvl9pPr marL="5080086" indent="0">
              <a:buNone/>
              <a:defRPr sz="222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29376" y="5102931"/>
            <a:ext cx="5399154" cy="750564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39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3190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860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4781" y="931334"/>
            <a:ext cx="4096081" cy="3259667"/>
          </a:xfrm>
        </p:spPr>
        <p:txBody>
          <a:bodyPr anchor="b"/>
          <a:lstStyle>
            <a:lvl1pPr>
              <a:defRPr sz="44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99156" y="2011425"/>
            <a:ext cx="6429375" cy="9927755"/>
          </a:xfrm>
        </p:spPr>
        <p:txBody>
          <a:bodyPr/>
          <a:lstStyle>
            <a:lvl1pPr>
              <a:defRPr sz="4444"/>
            </a:lvl1pPr>
            <a:lvl2pPr>
              <a:defRPr sz="3889"/>
            </a:lvl2pPr>
            <a:lvl3pPr>
              <a:defRPr sz="3333"/>
            </a:lvl3pPr>
            <a:lvl4pPr>
              <a:defRPr sz="2778"/>
            </a:lvl4pPr>
            <a:lvl5pPr>
              <a:defRPr sz="2778"/>
            </a:lvl5pPr>
            <a:lvl6pPr>
              <a:defRPr sz="2778"/>
            </a:lvl6pPr>
            <a:lvl7pPr>
              <a:defRPr sz="2778"/>
            </a:lvl7pPr>
            <a:lvl8pPr>
              <a:defRPr sz="2778"/>
            </a:lvl8pPr>
            <a:lvl9pPr>
              <a:defRPr sz="2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74781" y="4191000"/>
            <a:ext cx="4096081" cy="7764346"/>
          </a:xfrm>
        </p:spPr>
        <p:txBody>
          <a:bodyPr/>
          <a:lstStyle>
            <a:lvl1pPr marL="0" indent="0">
              <a:buNone/>
              <a:defRPr sz="2222"/>
            </a:lvl1pPr>
            <a:lvl2pPr marL="635011" indent="0">
              <a:buNone/>
              <a:defRPr sz="1944"/>
            </a:lvl2pPr>
            <a:lvl3pPr marL="1270021" indent="0">
              <a:buNone/>
              <a:defRPr sz="1667"/>
            </a:lvl3pPr>
            <a:lvl4pPr marL="1905032" indent="0">
              <a:buNone/>
              <a:defRPr sz="1389"/>
            </a:lvl4pPr>
            <a:lvl5pPr marL="2540043" indent="0">
              <a:buNone/>
              <a:defRPr sz="1389"/>
            </a:lvl5pPr>
            <a:lvl6pPr marL="3175053" indent="0">
              <a:buNone/>
              <a:defRPr sz="1389"/>
            </a:lvl6pPr>
            <a:lvl7pPr marL="3810064" indent="0">
              <a:buNone/>
              <a:defRPr sz="1389"/>
            </a:lvl7pPr>
            <a:lvl8pPr marL="4445076" indent="0">
              <a:buNone/>
              <a:defRPr sz="1389"/>
            </a:lvl8pPr>
            <a:lvl9pPr marL="5080086" indent="0">
              <a:buNone/>
              <a:defRPr sz="138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9190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4781" y="931334"/>
            <a:ext cx="4096081" cy="3259667"/>
          </a:xfrm>
        </p:spPr>
        <p:txBody>
          <a:bodyPr anchor="b"/>
          <a:lstStyle>
            <a:lvl1pPr>
              <a:defRPr sz="44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99156" y="2011425"/>
            <a:ext cx="6429375" cy="9927755"/>
          </a:xfrm>
        </p:spPr>
        <p:txBody>
          <a:bodyPr anchor="t"/>
          <a:lstStyle>
            <a:lvl1pPr marL="0" indent="0">
              <a:buNone/>
              <a:defRPr sz="4444"/>
            </a:lvl1pPr>
            <a:lvl2pPr marL="635011" indent="0">
              <a:buNone/>
              <a:defRPr sz="3889"/>
            </a:lvl2pPr>
            <a:lvl3pPr marL="1270021" indent="0">
              <a:buNone/>
              <a:defRPr sz="3333"/>
            </a:lvl3pPr>
            <a:lvl4pPr marL="1905032" indent="0">
              <a:buNone/>
              <a:defRPr sz="2778"/>
            </a:lvl4pPr>
            <a:lvl5pPr marL="2540043" indent="0">
              <a:buNone/>
              <a:defRPr sz="2778"/>
            </a:lvl5pPr>
            <a:lvl6pPr marL="3175053" indent="0">
              <a:buNone/>
              <a:defRPr sz="2778"/>
            </a:lvl6pPr>
            <a:lvl7pPr marL="3810064" indent="0">
              <a:buNone/>
              <a:defRPr sz="2778"/>
            </a:lvl7pPr>
            <a:lvl8pPr marL="4445076" indent="0">
              <a:buNone/>
              <a:defRPr sz="2778"/>
            </a:lvl8pPr>
            <a:lvl9pPr marL="5080086" indent="0">
              <a:buNone/>
              <a:defRPr sz="2778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74781" y="4191000"/>
            <a:ext cx="4096081" cy="7764346"/>
          </a:xfrm>
        </p:spPr>
        <p:txBody>
          <a:bodyPr/>
          <a:lstStyle>
            <a:lvl1pPr marL="0" indent="0">
              <a:buNone/>
              <a:defRPr sz="2222"/>
            </a:lvl1pPr>
            <a:lvl2pPr marL="635011" indent="0">
              <a:buNone/>
              <a:defRPr sz="1944"/>
            </a:lvl2pPr>
            <a:lvl3pPr marL="1270021" indent="0">
              <a:buNone/>
              <a:defRPr sz="1667"/>
            </a:lvl3pPr>
            <a:lvl4pPr marL="1905032" indent="0">
              <a:buNone/>
              <a:defRPr sz="1389"/>
            </a:lvl4pPr>
            <a:lvl5pPr marL="2540043" indent="0">
              <a:buNone/>
              <a:defRPr sz="1389"/>
            </a:lvl5pPr>
            <a:lvl6pPr marL="3175053" indent="0">
              <a:buNone/>
              <a:defRPr sz="1389"/>
            </a:lvl6pPr>
            <a:lvl7pPr marL="3810064" indent="0">
              <a:buNone/>
              <a:defRPr sz="1389"/>
            </a:lvl7pPr>
            <a:lvl8pPr marL="4445076" indent="0">
              <a:buNone/>
              <a:defRPr sz="1389"/>
            </a:lvl8pPr>
            <a:lvl9pPr marL="5080086" indent="0">
              <a:buNone/>
              <a:defRPr sz="138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6589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73125" y="743777"/>
            <a:ext cx="10953750" cy="27002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125" y="3718867"/>
            <a:ext cx="10953750" cy="88638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73125" y="12948125"/>
            <a:ext cx="2857500" cy="7437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1F2BE7-449E-424F-852E-4B789EAA5ED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06875" y="12948125"/>
            <a:ext cx="4286250" cy="7437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969375" y="12948125"/>
            <a:ext cx="2857500" cy="7437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74352-F5C8-415B-B903-89CAEB6F6B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4831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70021" rtl="0" eaLnBrk="1" latinLnBrk="0" hangingPunct="1">
        <a:lnSpc>
          <a:spcPct val="90000"/>
        </a:lnSpc>
        <a:spcBef>
          <a:spcPct val="0"/>
        </a:spcBef>
        <a:buNone/>
        <a:defRPr kumimoji="1" sz="61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7506" indent="-317506" algn="l" defTabSz="1270021" rtl="0" eaLnBrk="1" latinLnBrk="0" hangingPunct="1">
        <a:lnSpc>
          <a:spcPct val="90000"/>
        </a:lnSpc>
        <a:spcBef>
          <a:spcPts val="1389"/>
        </a:spcBef>
        <a:buFont typeface="Arial" panose="020B0604020202020204" pitchFamily="34" charset="0"/>
        <a:buChar char="•"/>
        <a:defRPr kumimoji="1" sz="3889" kern="1200">
          <a:solidFill>
            <a:schemeClr val="tx1"/>
          </a:solidFill>
          <a:latin typeface="+mn-lt"/>
          <a:ea typeface="+mn-ea"/>
          <a:cs typeface="+mn-cs"/>
        </a:defRPr>
      </a:lvl1pPr>
      <a:lvl2pPr marL="952516" indent="-317506" algn="l" defTabSz="1270021" rtl="0" eaLnBrk="1" latinLnBrk="0" hangingPunct="1">
        <a:lnSpc>
          <a:spcPct val="90000"/>
        </a:lnSpc>
        <a:spcBef>
          <a:spcPts val="694"/>
        </a:spcBef>
        <a:buFont typeface="Arial" panose="020B0604020202020204" pitchFamily="34" charset="0"/>
        <a:buChar char="•"/>
        <a:defRPr kumimoji="1" sz="3333" kern="1200">
          <a:solidFill>
            <a:schemeClr val="tx1"/>
          </a:solidFill>
          <a:latin typeface="+mn-lt"/>
          <a:ea typeface="+mn-ea"/>
          <a:cs typeface="+mn-cs"/>
        </a:defRPr>
      </a:lvl2pPr>
      <a:lvl3pPr marL="1587527" indent="-317506" algn="l" defTabSz="1270021" rtl="0" eaLnBrk="1" latinLnBrk="0" hangingPunct="1">
        <a:lnSpc>
          <a:spcPct val="90000"/>
        </a:lnSpc>
        <a:spcBef>
          <a:spcPts val="694"/>
        </a:spcBef>
        <a:buFont typeface="Arial" panose="020B0604020202020204" pitchFamily="34" charset="0"/>
        <a:buChar char="•"/>
        <a:defRPr kumimoji="1" sz="2778" kern="1200">
          <a:solidFill>
            <a:schemeClr val="tx1"/>
          </a:solidFill>
          <a:latin typeface="+mn-lt"/>
          <a:ea typeface="+mn-ea"/>
          <a:cs typeface="+mn-cs"/>
        </a:defRPr>
      </a:lvl3pPr>
      <a:lvl4pPr marL="2222538" indent="-317506" algn="l" defTabSz="1270021" rtl="0" eaLnBrk="1" latinLnBrk="0" hangingPunct="1">
        <a:lnSpc>
          <a:spcPct val="90000"/>
        </a:lnSpc>
        <a:spcBef>
          <a:spcPts val="694"/>
        </a:spcBef>
        <a:buFont typeface="Arial" panose="020B0604020202020204" pitchFamily="34" charset="0"/>
        <a:buChar char="•"/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857548" indent="-317506" algn="l" defTabSz="1270021" rtl="0" eaLnBrk="1" latinLnBrk="0" hangingPunct="1">
        <a:lnSpc>
          <a:spcPct val="90000"/>
        </a:lnSpc>
        <a:spcBef>
          <a:spcPts val="694"/>
        </a:spcBef>
        <a:buFont typeface="Arial" panose="020B0604020202020204" pitchFamily="34" charset="0"/>
        <a:buChar char="•"/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492559" indent="-317506" algn="l" defTabSz="1270021" rtl="0" eaLnBrk="1" latinLnBrk="0" hangingPunct="1">
        <a:lnSpc>
          <a:spcPct val="90000"/>
        </a:lnSpc>
        <a:spcBef>
          <a:spcPts val="694"/>
        </a:spcBef>
        <a:buFont typeface="Arial" panose="020B0604020202020204" pitchFamily="34" charset="0"/>
        <a:buChar char="•"/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4127570" indent="-317506" algn="l" defTabSz="1270021" rtl="0" eaLnBrk="1" latinLnBrk="0" hangingPunct="1">
        <a:lnSpc>
          <a:spcPct val="90000"/>
        </a:lnSpc>
        <a:spcBef>
          <a:spcPts val="694"/>
        </a:spcBef>
        <a:buFont typeface="Arial" panose="020B0604020202020204" pitchFamily="34" charset="0"/>
        <a:buChar char="•"/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762581" indent="-317506" algn="l" defTabSz="1270021" rtl="0" eaLnBrk="1" latinLnBrk="0" hangingPunct="1">
        <a:lnSpc>
          <a:spcPct val="90000"/>
        </a:lnSpc>
        <a:spcBef>
          <a:spcPts val="694"/>
        </a:spcBef>
        <a:buFont typeface="Arial" panose="020B0604020202020204" pitchFamily="34" charset="0"/>
        <a:buChar char="•"/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397591" indent="-317506" algn="l" defTabSz="1270021" rtl="0" eaLnBrk="1" latinLnBrk="0" hangingPunct="1">
        <a:lnSpc>
          <a:spcPct val="90000"/>
        </a:lnSpc>
        <a:spcBef>
          <a:spcPts val="694"/>
        </a:spcBef>
        <a:buFont typeface="Arial" panose="020B0604020202020204" pitchFamily="34" charset="0"/>
        <a:buChar char="•"/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70021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35011" algn="l" defTabSz="1270021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70021" algn="l" defTabSz="1270021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05032" algn="l" defTabSz="1270021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40043" algn="l" defTabSz="1270021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75053" algn="l" defTabSz="1270021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10064" algn="l" defTabSz="1270021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45076" algn="l" defTabSz="1270021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080086" algn="l" defTabSz="1270021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2351112-21C5-48B9-FC69-71E44166060C}"/>
              </a:ext>
            </a:extLst>
          </p:cNvPr>
          <p:cNvSpPr txBox="1"/>
          <p:nvPr/>
        </p:nvSpPr>
        <p:spPr>
          <a:xfrm>
            <a:off x="84193" y="13417245"/>
            <a:ext cx="46142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</a:t>
            </a:r>
            <a:r>
              <a:rPr kumimoji="1" lang="ja-JP" alt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39">
            <a:extLst>
              <a:ext uri="{FF2B5EF4-FFF2-40B4-BE49-F238E27FC236}">
                <a16:creationId xmlns:a16="http://schemas.microsoft.com/office/drawing/2014/main" id="{62DA0E3C-B458-D436-2525-B9114D254768}"/>
              </a:ext>
            </a:extLst>
          </p:cNvPr>
          <p:cNvSpPr txBox="1"/>
          <p:nvPr/>
        </p:nvSpPr>
        <p:spPr>
          <a:xfrm>
            <a:off x="357848" y="246251"/>
            <a:ext cx="4318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 descr="オウムの絵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F2AE1E5A-33D7-C606-96A8-A7A795FF64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44" r="48986" b="18549"/>
          <a:stretch/>
        </p:blipFill>
        <p:spPr>
          <a:xfrm>
            <a:off x="1613902" y="857832"/>
            <a:ext cx="5355611" cy="5984859"/>
          </a:xfrm>
          <a:prstGeom prst="rect">
            <a:avLst/>
          </a:prstGeom>
        </p:spPr>
      </p:pic>
      <p:pic>
        <p:nvPicPr>
          <p:cNvPr id="8" name="図 7" descr="等高線グラフ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EDD2C600-8256-00B4-3FAF-871C1173BD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22" r="46527" b="17124"/>
          <a:stretch/>
        </p:blipFill>
        <p:spPr>
          <a:xfrm>
            <a:off x="7168995" y="1010232"/>
            <a:ext cx="5531005" cy="5984859"/>
          </a:xfrm>
          <a:prstGeom prst="rect">
            <a:avLst/>
          </a:prstGeom>
        </p:spPr>
      </p:pic>
      <p:pic>
        <p:nvPicPr>
          <p:cNvPr id="9" name="図 8" descr="オウムの絵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42E0E764-AA98-D560-7642-79B380E2CA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1277" b="51374"/>
          <a:stretch/>
        </p:blipFill>
        <p:spPr>
          <a:xfrm>
            <a:off x="726531" y="1934017"/>
            <a:ext cx="1107688" cy="35729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87166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B444F18-3422-1BB5-35D4-C3A2811CA6F0}"/>
              </a:ext>
            </a:extLst>
          </p:cNvPr>
          <p:cNvSpPr txBox="1"/>
          <p:nvPr/>
        </p:nvSpPr>
        <p:spPr>
          <a:xfrm>
            <a:off x="5423229" y="5373251"/>
            <a:ext cx="605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S</a:t>
            </a:r>
            <a:endParaRPr kumimoji="1" lang="ja-JP" altLang="en-US" sz="16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08CF660F-0619-7414-C5BD-B9E46ED2D331}"/>
              </a:ext>
            </a:extLst>
          </p:cNvPr>
          <p:cNvCxnSpPr>
            <a:cxnSpLocks/>
          </p:cNvCxnSpPr>
          <p:nvPr/>
        </p:nvCxnSpPr>
        <p:spPr>
          <a:xfrm>
            <a:off x="5916801" y="1454763"/>
            <a:ext cx="0" cy="1166335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5363AC42-80E2-A083-B517-AB286D3911C8}"/>
              </a:ext>
            </a:extLst>
          </p:cNvPr>
          <p:cNvCxnSpPr>
            <a:cxnSpLocks/>
          </p:cNvCxnSpPr>
          <p:nvPr/>
        </p:nvCxnSpPr>
        <p:spPr>
          <a:xfrm>
            <a:off x="5893402" y="5254388"/>
            <a:ext cx="0" cy="639389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90ECE83A-962F-F091-06A3-BF4A9EC6D9F9}"/>
              </a:ext>
            </a:extLst>
          </p:cNvPr>
          <p:cNvCxnSpPr>
            <a:cxnSpLocks/>
          </p:cNvCxnSpPr>
          <p:nvPr/>
        </p:nvCxnSpPr>
        <p:spPr>
          <a:xfrm>
            <a:off x="5916801" y="2872069"/>
            <a:ext cx="0" cy="1564485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DD4D084-7CDD-870D-CAF5-29444D9E9161}"/>
              </a:ext>
            </a:extLst>
          </p:cNvPr>
          <p:cNvSpPr txBox="1"/>
          <p:nvPr/>
        </p:nvSpPr>
        <p:spPr>
          <a:xfrm>
            <a:off x="3823850" y="3501039"/>
            <a:ext cx="15337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u="sng" dirty="0">
                <a:solidFill>
                  <a:srgbClr val="FF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HD-Grid</a:t>
            </a:r>
            <a:endParaRPr kumimoji="1" lang="ja-JP" altLang="en-US" sz="2000" b="1" u="sng" dirty="0">
              <a:solidFill>
                <a:srgbClr val="FF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8871145-715A-8F54-7D3B-C7184D269DD5}"/>
              </a:ext>
            </a:extLst>
          </p:cNvPr>
          <p:cNvSpPr txBox="1"/>
          <p:nvPr/>
        </p:nvSpPr>
        <p:spPr>
          <a:xfrm>
            <a:off x="5467466" y="1095853"/>
            <a:ext cx="7706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VF</a:t>
            </a:r>
            <a:endParaRPr kumimoji="1" lang="ja-JP" altLang="en-US" sz="16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ED58E30-1A74-0152-AFB3-3718072DADDD}"/>
              </a:ext>
            </a:extLst>
          </p:cNvPr>
          <p:cNvSpPr txBox="1"/>
          <p:nvPr/>
        </p:nvSpPr>
        <p:spPr>
          <a:xfrm>
            <a:off x="5423229" y="1868654"/>
            <a:ext cx="7706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A</a:t>
            </a:r>
            <a:endParaRPr kumimoji="1" lang="ja-JP" altLang="en-US" sz="16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B8A7A798-EA6B-4DFA-D50E-AFF0ADA2278A}"/>
              </a:ext>
            </a:extLst>
          </p:cNvPr>
          <p:cNvCxnSpPr>
            <a:cxnSpLocks/>
          </p:cNvCxnSpPr>
          <p:nvPr/>
        </p:nvCxnSpPr>
        <p:spPr>
          <a:xfrm>
            <a:off x="11404259" y="6392263"/>
            <a:ext cx="594000" cy="0"/>
          </a:xfrm>
          <a:prstGeom prst="straightConnector1">
            <a:avLst/>
          </a:prstGeom>
          <a:ln w="19050">
            <a:headEnd type="triangle"/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85D0029-0042-6BE0-D2E5-2E8E8E18C31F}"/>
              </a:ext>
            </a:extLst>
          </p:cNvPr>
          <p:cNvSpPr txBox="1"/>
          <p:nvPr/>
        </p:nvSpPr>
        <p:spPr>
          <a:xfrm>
            <a:off x="11339079" y="6399403"/>
            <a:ext cx="158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 </a:t>
            </a:r>
            <a:r>
              <a:rPr lang="en-US" altLang="ja-JP" sz="1400" dirty="0" err="1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ms</a:t>
            </a:r>
            <a:endParaRPr kumimoji="1" lang="ja-JP" altLang="en-US" sz="14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6FA342AE-3340-E427-1BD8-B867B403F5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1082" y="750682"/>
            <a:ext cx="3150467" cy="3150467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088B22D8-072F-A719-9791-6186366629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2998" y="3687753"/>
            <a:ext cx="3150467" cy="3150467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7D05DDB-35CD-7BD6-726B-2984C4E77EB5}"/>
              </a:ext>
            </a:extLst>
          </p:cNvPr>
          <p:cNvSpPr txBox="1"/>
          <p:nvPr/>
        </p:nvSpPr>
        <p:spPr>
          <a:xfrm>
            <a:off x="3072571" y="5522754"/>
            <a:ext cx="692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S</a:t>
            </a:r>
            <a:endParaRPr kumimoji="1"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B3246AA-0B2F-A094-2E76-A5E38F0C45A3}"/>
              </a:ext>
            </a:extLst>
          </p:cNvPr>
          <p:cNvSpPr txBox="1"/>
          <p:nvPr/>
        </p:nvSpPr>
        <p:spPr>
          <a:xfrm>
            <a:off x="2951590" y="3700133"/>
            <a:ext cx="94754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LAO45</a:t>
            </a:r>
            <a:endParaRPr kumimoji="1" lang="ja-JP" altLang="en-US" sz="1400" b="1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919C74B-9C9A-9309-78D3-C169230C7366}"/>
              </a:ext>
            </a:extLst>
          </p:cNvPr>
          <p:cNvSpPr txBox="1"/>
          <p:nvPr/>
        </p:nvSpPr>
        <p:spPr>
          <a:xfrm>
            <a:off x="3000192" y="762316"/>
            <a:ext cx="94754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RAO30</a:t>
            </a:r>
            <a:endParaRPr kumimoji="1" lang="ja-JP" altLang="en-US" sz="1400" b="1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3517E8D-7F62-FA7D-0133-313468E5CB3B}"/>
              </a:ext>
            </a:extLst>
          </p:cNvPr>
          <p:cNvSpPr txBox="1"/>
          <p:nvPr/>
        </p:nvSpPr>
        <p:spPr>
          <a:xfrm>
            <a:off x="2286315" y="4938557"/>
            <a:ext cx="925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HDG</a:t>
            </a:r>
            <a:endParaRPr kumimoji="1" lang="ja-JP" altLang="en-US" sz="2000" b="1" dirty="0">
              <a:solidFill>
                <a:schemeClr val="bg1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382A47F-C557-F11E-416E-CFAD02942AF5}"/>
              </a:ext>
            </a:extLst>
          </p:cNvPr>
          <p:cNvSpPr txBox="1"/>
          <p:nvPr/>
        </p:nvSpPr>
        <p:spPr>
          <a:xfrm>
            <a:off x="822724" y="4830835"/>
            <a:ext cx="692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</a:t>
            </a:r>
            <a:r>
              <a:rPr kumimoji="1"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</a:t>
            </a:r>
            <a:endParaRPr kumimoji="1"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400964F-481D-D21F-B919-37410A69C1D5}"/>
              </a:ext>
            </a:extLst>
          </p:cNvPr>
          <p:cNvSpPr txBox="1"/>
          <p:nvPr/>
        </p:nvSpPr>
        <p:spPr>
          <a:xfrm>
            <a:off x="624891" y="3102934"/>
            <a:ext cx="925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HDG</a:t>
            </a:r>
            <a:endParaRPr kumimoji="1" lang="ja-JP" altLang="en-US" sz="2000" b="1" dirty="0">
              <a:solidFill>
                <a:schemeClr val="bg1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3943C1F-E713-D244-D8AD-743E932F280B}"/>
              </a:ext>
            </a:extLst>
          </p:cNvPr>
          <p:cNvSpPr txBox="1"/>
          <p:nvPr/>
        </p:nvSpPr>
        <p:spPr>
          <a:xfrm>
            <a:off x="2356127" y="2562372"/>
            <a:ext cx="692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S</a:t>
            </a:r>
            <a:endParaRPr kumimoji="1"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72704CA-794C-9EE4-4A7F-9A225ED1BF2F}"/>
              </a:ext>
            </a:extLst>
          </p:cNvPr>
          <p:cNvSpPr txBox="1"/>
          <p:nvPr/>
        </p:nvSpPr>
        <p:spPr>
          <a:xfrm>
            <a:off x="792010" y="2039722"/>
            <a:ext cx="692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A</a:t>
            </a:r>
            <a:endParaRPr kumimoji="1"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3F7D589F-9F46-4C18-CE32-9E4F8BE773CE}"/>
              </a:ext>
            </a:extLst>
          </p:cNvPr>
          <p:cNvCxnSpPr>
            <a:cxnSpLocks/>
          </p:cNvCxnSpPr>
          <p:nvPr/>
        </p:nvCxnSpPr>
        <p:spPr>
          <a:xfrm flipH="1">
            <a:off x="2349012" y="5297706"/>
            <a:ext cx="252130" cy="205032"/>
          </a:xfrm>
          <a:prstGeom prst="straightConnector1">
            <a:avLst/>
          </a:prstGeom>
          <a:ln w="444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AC9A7713-CEA4-4093-67F1-40E322DD638A}"/>
              </a:ext>
            </a:extLst>
          </p:cNvPr>
          <p:cNvCxnSpPr>
            <a:cxnSpLocks/>
          </p:cNvCxnSpPr>
          <p:nvPr/>
        </p:nvCxnSpPr>
        <p:spPr>
          <a:xfrm flipV="1">
            <a:off x="1138374" y="2895127"/>
            <a:ext cx="202353" cy="203091"/>
          </a:xfrm>
          <a:prstGeom prst="straightConnector1">
            <a:avLst/>
          </a:prstGeom>
          <a:ln w="444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図 22" descr="ダイアグラム, 設計図&#10;&#10;自動的に生成された説明">
            <a:extLst>
              <a:ext uri="{FF2B5EF4-FFF2-40B4-BE49-F238E27FC236}">
                <a16:creationId xmlns:a16="http://schemas.microsoft.com/office/drawing/2014/main" id="{D313BB24-6A8B-F721-BD28-93AC1511C2E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24" t="4711" r="3988" b="37987"/>
          <a:stretch/>
        </p:blipFill>
        <p:spPr>
          <a:xfrm>
            <a:off x="6093558" y="909711"/>
            <a:ext cx="6471157" cy="3526843"/>
          </a:xfrm>
          <a:prstGeom prst="rect">
            <a:avLst/>
          </a:prstGeom>
        </p:spPr>
      </p:pic>
      <p:pic>
        <p:nvPicPr>
          <p:cNvPr id="24" name="図 23" descr="ダイアグラム, 設計図&#10;&#10;自動的に生成された説明">
            <a:extLst>
              <a:ext uri="{FF2B5EF4-FFF2-40B4-BE49-F238E27FC236}">
                <a16:creationId xmlns:a16="http://schemas.microsoft.com/office/drawing/2014/main" id="{F1974D77-EE64-BFB3-6268-D101A76C1E8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24" t="75892" r="3988" b="3872"/>
          <a:stretch/>
        </p:blipFill>
        <p:spPr>
          <a:xfrm>
            <a:off x="6070159" y="5068266"/>
            <a:ext cx="6471157" cy="1245475"/>
          </a:xfrm>
          <a:prstGeom prst="rect">
            <a:avLst/>
          </a:prstGeom>
        </p:spPr>
      </p:pic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915D39F2-E4CF-068B-3DCF-47AA95274D03}"/>
              </a:ext>
            </a:extLst>
          </p:cNvPr>
          <p:cNvCxnSpPr>
            <a:cxnSpLocks/>
            <a:stCxn id="23" idx="0"/>
          </p:cNvCxnSpPr>
          <p:nvPr/>
        </p:nvCxnSpPr>
        <p:spPr>
          <a:xfrm>
            <a:off x="9329137" y="909711"/>
            <a:ext cx="42472" cy="5482552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楕円 26">
            <a:extLst>
              <a:ext uri="{FF2B5EF4-FFF2-40B4-BE49-F238E27FC236}">
                <a16:creationId xmlns:a16="http://schemas.microsoft.com/office/drawing/2014/main" id="{90B288B8-07DB-4725-888D-CABDB873EED8}"/>
              </a:ext>
            </a:extLst>
          </p:cNvPr>
          <p:cNvSpPr/>
          <p:nvPr/>
        </p:nvSpPr>
        <p:spPr>
          <a:xfrm>
            <a:off x="1227626" y="2601323"/>
            <a:ext cx="208853" cy="268825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楕円 27">
            <a:extLst>
              <a:ext uri="{FF2B5EF4-FFF2-40B4-BE49-F238E27FC236}">
                <a16:creationId xmlns:a16="http://schemas.microsoft.com/office/drawing/2014/main" id="{1C13E2F6-4B24-5E80-6382-C8A77D41F6CE}"/>
              </a:ext>
            </a:extLst>
          </p:cNvPr>
          <p:cNvSpPr/>
          <p:nvPr/>
        </p:nvSpPr>
        <p:spPr>
          <a:xfrm>
            <a:off x="2119356" y="5532750"/>
            <a:ext cx="345134" cy="383328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A7621EA-1FEB-BCA6-8CDC-E882921144DF}"/>
              </a:ext>
            </a:extLst>
          </p:cNvPr>
          <p:cNvSpPr txBox="1"/>
          <p:nvPr/>
        </p:nvSpPr>
        <p:spPr>
          <a:xfrm>
            <a:off x="5614226" y="5783593"/>
            <a:ext cx="605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d</a:t>
            </a:r>
            <a:endParaRPr kumimoji="1" lang="ja-JP" altLang="en-US" sz="16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CF36365-8CFF-8852-08BA-1C162258B91E}"/>
              </a:ext>
            </a:extLst>
          </p:cNvPr>
          <p:cNvSpPr txBox="1"/>
          <p:nvPr/>
        </p:nvSpPr>
        <p:spPr>
          <a:xfrm>
            <a:off x="5614226" y="4982604"/>
            <a:ext cx="605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p</a:t>
            </a:r>
            <a:endParaRPr kumimoji="1" lang="ja-JP" altLang="en-US" sz="16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C64475B-CCA6-D1A2-A0E5-246106E9D2C7}"/>
              </a:ext>
            </a:extLst>
          </p:cNvPr>
          <p:cNvSpPr txBox="1"/>
          <p:nvPr/>
        </p:nvSpPr>
        <p:spPr>
          <a:xfrm>
            <a:off x="5290244" y="2707523"/>
            <a:ext cx="647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1-A2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2E505D8-913D-AB07-C552-9525B0B36200}"/>
              </a:ext>
            </a:extLst>
          </p:cNvPr>
          <p:cNvSpPr txBox="1"/>
          <p:nvPr/>
        </p:nvSpPr>
        <p:spPr>
          <a:xfrm>
            <a:off x="5290244" y="2846022"/>
            <a:ext cx="647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2-A3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24FEB6C7-85C1-7F43-989E-B8EEF6B9BBAF}"/>
              </a:ext>
            </a:extLst>
          </p:cNvPr>
          <p:cNvSpPr txBox="1"/>
          <p:nvPr/>
        </p:nvSpPr>
        <p:spPr>
          <a:xfrm>
            <a:off x="5291814" y="2998500"/>
            <a:ext cx="647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3-A4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6D2BC3F-63BD-13EE-125E-7FAA738DDCAB}"/>
              </a:ext>
            </a:extLst>
          </p:cNvPr>
          <p:cNvSpPr txBox="1"/>
          <p:nvPr/>
        </p:nvSpPr>
        <p:spPr>
          <a:xfrm>
            <a:off x="5290244" y="3150977"/>
            <a:ext cx="647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B1</a:t>
            </a:r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-B2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4D82EA6-1FBA-C03A-34E9-2B2F5FF70744}"/>
              </a:ext>
            </a:extLst>
          </p:cNvPr>
          <p:cNvSpPr txBox="1"/>
          <p:nvPr/>
        </p:nvSpPr>
        <p:spPr>
          <a:xfrm>
            <a:off x="5290244" y="3285502"/>
            <a:ext cx="647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B2</a:t>
            </a:r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-B3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BFD884D-5BE4-478D-6E36-0C2E8308C851}"/>
              </a:ext>
            </a:extLst>
          </p:cNvPr>
          <p:cNvSpPr txBox="1"/>
          <p:nvPr/>
        </p:nvSpPr>
        <p:spPr>
          <a:xfrm>
            <a:off x="5290243" y="3430528"/>
            <a:ext cx="764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B3</a:t>
            </a:r>
            <a:r>
              <a:rPr kumimoji="1"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-B4</a:t>
            </a:r>
            <a:endParaRPr kumimoji="1" lang="ja-JP" altLang="en-US" sz="1200" b="1" dirty="0">
              <a:solidFill>
                <a:srgbClr val="FF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9CCBC1B-EEA5-3F3E-A596-8ECBE5523111}"/>
              </a:ext>
            </a:extLst>
          </p:cNvPr>
          <p:cNvSpPr txBox="1"/>
          <p:nvPr/>
        </p:nvSpPr>
        <p:spPr>
          <a:xfrm>
            <a:off x="5292691" y="3567042"/>
            <a:ext cx="647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</a:t>
            </a:r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-C2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7E9BDF1-00BE-0FD6-22CC-1E4778A8AE13}"/>
              </a:ext>
            </a:extLst>
          </p:cNvPr>
          <p:cNvSpPr txBox="1"/>
          <p:nvPr/>
        </p:nvSpPr>
        <p:spPr>
          <a:xfrm>
            <a:off x="5292691" y="3705541"/>
            <a:ext cx="647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</a:t>
            </a:r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-C3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569D635-070F-EEFB-AB96-D4EE02A1E718}"/>
              </a:ext>
            </a:extLst>
          </p:cNvPr>
          <p:cNvSpPr txBox="1"/>
          <p:nvPr/>
        </p:nvSpPr>
        <p:spPr>
          <a:xfrm>
            <a:off x="5294260" y="3831895"/>
            <a:ext cx="764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</a:t>
            </a:r>
            <a:r>
              <a:rPr kumimoji="1"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-C4</a:t>
            </a:r>
            <a:endParaRPr kumimoji="1" lang="ja-JP" altLang="en-US" sz="1200" b="1" dirty="0">
              <a:solidFill>
                <a:srgbClr val="FF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7389EAE-D56F-B01E-25F6-666C89BD2C57}"/>
              </a:ext>
            </a:extLst>
          </p:cNvPr>
          <p:cNvSpPr txBox="1"/>
          <p:nvPr/>
        </p:nvSpPr>
        <p:spPr>
          <a:xfrm>
            <a:off x="5292691" y="3977841"/>
            <a:ext cx="770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D1-D</a:t>
            </a:r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7E6CE27B-3C4E-67BF-C817-3B8A67726190}"/>
              </a:ext>
            </a:extLst>
          </p:cNvPr>
          <p:cNvSpPr txBox="1"/>
          <p:nvPr/>
        </p:nvSpPr>
        <p:spPr>
          <a:xfrm>
            <a:off x="5292691" y="4112366"/>
            <a:ext cx="7165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D2</a:t>
            </a:r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-D3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A8B281D1-D4F8-D18F-3CC1-F8B9A0359B80}"/>
              </a:ext>
            </a:extLst>
          </p:cNvPr>
          <p:cNvSpPr txBox="1"/>
          <p:nvPr/>
        </p:nvSpPr>
        <p:spPr>
          <a:xfrm>
            <a:off x="5292690" y="4257392"/>
            <a:ext cx="735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D3</a:t>
            </a:r>
            <a:r>
              <a:rPr kumimoji="1" lang="en-US" altLang="ja-JP" sz="12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-D4</a:t>
            </a:r>
            <a:endParaRPr kumimoji="1" lang="ja-JP" altLang="en-US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378C033-4EEF-3007-BEF6-DCE6FF725B13}"/>
              </a:ext>
            </a:extLst>
          </p:cNvPr>
          <p:cNvSpPr txBox="1"/>
          <p:nvPr/>
        </p:nvSpPr>
        <p:spPr>
          <a:xfrm>
            <a:off x="5615368" y="2412672"/>
            <a:ext cx="605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p</a:t>
            </a:r>
            <a:endParaRPr kumimoji="1" lang="ja-JP" altLang="en-US" sz="16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0142908-8CE7-AD40-3BE0-2F7ABCF3D641}"/>
              </a:ext>
            </a:extLst>
          </p:cNvPr>
          <p:cNvSpPr txBox="1"/>
          <p:nvPr/>
        </p:nvSpPr>
        <p:spPr>
          <a:xfrm>
            <a:off x="5615368" y="1386833"/>
            <a:ext cx="605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d</a:t>
            </a:r>
            <a:endParaRPr kumimoji="1" lang="ja-JP" altLang="en-US" sz="16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5B6BB97-2545-60B1-9828-823C2AB0DC41}"/>
              </a:ext>
            </a:extLst>
          </p:cNvPr>
          <p:cNvSpPr txBox="1"/>
          <p:nvPr/>
        </p:nvSpPr>
        <p:spPr>
          <a:xfrm>
            <a:off x="7766782" y="966299"/>
            <a:ext cx="36374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F</a:t>
            </a:r>
            <a:endParaRPr kumimoji="1" lang="ja-JP" altLang="en-US" sz="2000" b="1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8AAAFE8-6FFE-0727-C03D-5C1003A4455F}"/>
              </a:ext>
            </a:extLst>
          </p:cNvPr>
          <p:cNvSpPr txBox="1"/>
          <p:nvPr/>
        </p:nvSpPr>
        <p:spPr>
          <a:xfrm>
            <a:off x="84193" y="13417245"/>
            <a:ext cx="46142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</a:t>
            </a:r>
            <a:r>
              <a:rPr kumimoji="1" lang="ja-JP" alt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91D99E7-4472-F0FC-2650-6225344CA0DA}"/>
              </a:ext>
            </a:extLst>
          </p:cNvPr>
          <p:cNvSpPr txBox="1"/>
          <p:nvPr/>
        </p:nvSpPr>
        <p:spPr>
          <a:xfrm>
            <a:off x="4060908" y="2783056"/>
            <a:ext cx="10596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u="sng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Inferior </a:t>
            </a:r>
          </a:p>
          <a:p>
            <a:pPr algn="ctr"/>
            <a:r>
              <a:rPr kumimoji="1" lang="en-US" altLang="ja-JP" sz="2000" b="1" u="sng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V</a:t>
            </a:r>
            <a:endParaRPr kumimoji="1" lang="ja-JP" altLang="en-US" sz="2000" b="1" u="sng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8205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4809</TotalTime>
  <Words>40</Words>
  <Application>Microsoft Office PowerPoint</Application>
  <PresentationFormat>ユーザー設定</PresentationFormat>
  <Paragraphs>3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 雄也</dc:creator>
  <cp:lastModifiedBy>雄也 鈴木</cp:lastModifiedBy>
  <cp:revision>804</cp:revision>
  <dcterms:created xsi:type="dcterms:W3CDTF">2022-08-09T09:39:15Z</dcterms:created>
  <dcterms:modified xsi:type="dcterms:W3CDTF">2025-04-08T11:25:42Z</dcterms:modified>
</cp:coreProperties>
</file>